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media/image1.svg" ContentType="image/svg+xml"/>
  <Override PartName="/ppt/media/image2.svg" ContentType="image/svg+xml"/>
  <Override PartName="/ppt/media/image3.svg" ContentType="image/svg+xml"/>
  <Override PartName="/ppt/media/image4.svg" ContentType="image/svg+xml"/>
  <Override PartName="/ppt/media/image5.svg" ContentType="image/svg+xml"/>
  <Override PartName="/ppt/media/image6.svg" ContentType="image/svg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61" r:id="rId6"/>
  </p:sldIdLst>
  <p:sldSz cx="6858000" cy="9903460" type="A4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326" y="1620798"/>
            <a:ext cx="5143957" cy="34479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326" y="5201683"/>
            <a:ext cx="5143957" cy="23910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471529" y="527275"/>
            <a:ext cx="5915550" cy="83928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57" y="2469023"/>
            <a:ext cx="5915550" cy="411962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57" y="6627618"/>
            <a:ext cx="5915550" cy="21664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529" y="2636375"/>
            <a:ext cx="2914909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2171" y="2636375"/>
            <a:ext cx="2914909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422" y="527275"/>
            <a:ext cx="5915550" cy="191423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7619" y="2568233"/>
            <a:ext cx="2741629" cy="1189807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67619" y="3849059"/>
            <a:ext cx="2741629" cy="508939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519840" y="2568233"/>
            <a:ext cx="2755132" cy="1189807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519840" y="3849059"/>
            <a:ext cx="2755132" cy="508939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422" y="660240"/>
            <a:ext cx="2343217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802" y="660241"/>
            <a:ext cx="3472171" cy="780367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422" y="2971080"/>
            <a:ext cx="2343217" cy="5504293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8193" y="527275"/>
            <a:ext cx="1478887" cy="839284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529" y="527275"/>
            <a:ext cx="4350931" cy="839284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529" y="527275"/>
            <a:ext cx="5915550" cy="19142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529" y="2636375"/>
            <a:ext cx="5915550" cy="62837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529" y="9179170"/>
            <a:ext cx="1543187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915" y="9179170"/>
            <a:ext cx="2314781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893" y="9179170"/>
            <a:ext cx="1543187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9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.sv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svg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svg"/><Relationship Id="rId3" Type="http://schemas.openxmlformats.org/officeDocument/2006/relationships/image" Target="../media/image4.png"/><Relationship Id="rId2" Type="http://schemas.openxmlformats.org/officeDocument/2006/relationships/image" Target="../media/image3.svg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6.svg"/><Relationship Id="rId3" Type="http://schemas.openxmlformats.org/officeDocument/2006/relationships/image" Target="../media/image6.png"/><Relationship Id="rId2" Type="http://schemas.openxmlformats.org/officeDocument/2006/relationships/image" Target="../media/image5.svg"/><Relationship Id="rId1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p>
            <a:endParaRPr lang="zh-CN" altLang="en-US"/>
          </a:p>
        </p:txBody>
      </p:sp>
      <p:pic>
        <p:nvPicPr>
          <p:cNvPr id="5" name="图片 4" descr="ASEX"/>
          <p:cNvPicPr>
            <a:picLocks noChangeAspect="1"/>
          </p:cNvPicPr>
          <p:nvPr/>
        </p:nvPicPr>
        <p:blipFill>
          <a:blip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66675" y="1377950"/>
            <a:ext cx="6691630" cy="452247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03505" y="212725"/>
            <a:ext cx="6654800" cy="5397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60"/>
              <a:t>Fig. S1. Meta-analysis of ASEX scores in vitiligo and control groups, distinguishing between men and women.</a:t>
            </a:r>
            <a:endParaRPr lang="en-US" altLang="zh-CN" sz="146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33765" y="2246158"/>
            <a:ext cx="10726799" cy="2800610"/>
          </a:xfrm>
        </p:spPr>
        <p:txBody>
          <a:bodyPr/>
          <a:p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62230" y="188595"/>
            <a:ext cx="6587490" cy="3155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60"/>
              <a:t>Fig. S2. Meta-analysis of AVFSFI scores and their constituent scores.</a:t>
            </a:r>
            <a:endParaRPr lang="en-US" altLang="zh-CN" sz="1460"/>
          </a:p>
        </p:txBody>
      </p:sp>
      <p:pic>
        <p:nvPicPr>
          <p:cNvPr id="5" name="图片 4" descr="AVFSFI"/>
          <p:cNvPicPr>
            <a:picLocks noChangeAspect="1"/>
          </p:cNvPicPr>
          <p:nvPr/>
        </p:nvPicPr>
        <p:blipFill>
          <a:blip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62230" y="735965"/>
            <a:ext cx="6732905" cy="446595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0" y="207645"/>
            <a:ext cx="6412230" cy="3155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60"/>
              <a:t>Fig. S3.  Meta-analysis of DLQI scores and marital duration. </a:t>
            </a:r>
            <a:endParaRPr lang="en-US" altLang="zh-CN" sz="1460"/>
          </a:p>
        </p:txBody>
      </p:sp>
      <p:pic>
        <p:nvPicPr>
          <p:cNvPr id="5" name="图片 4" descr="DLQI"/>
          <p:cNvPicPr>
            <a:picLocks noChangeAspect="1"/>
          </p:cNvPicPr>
          <p:nvPr/>
        </p:nvPicPr>
        <p:blipFill>
          <a:blip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124460" y="812800"/>
            <a:ext cx="6617335" cy="3750945"/>
          </a:xfrm>
          <a:prstGeom prst="rect">
            <a:avLst/>
          </a:prstGeom>
        </p:spPr>
      </p:pic>
      <p:pic>
        <p:nvPicPr>
          <p:cNvPr id="6" name="图片 5" descr="marrige time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25095" y="5441315"/>
            <a:ext cx="6616700" cy="372999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38784" y="4673019"/>
            <a:ext cx="3396568" cy="2914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300"/>
              <a:t>a. </a:t>
            </a:r>
            <a:r>
              <a:rPr lang="en-US" altLang="zh-CN" sz="1300">
                <a:sym typeface="+mn-ea"/>
              </a:rPr>
              <a:t>Meta-analysis of DLQI scores</a:t>
            </a:r>
            <a:r>
              <a:rPr lang="en-US" altLang="zh-CN" sz="1300"/>
              <a:t> </a:t>
            </a:r>
            <a:endParaRPr lang="en-US" altLang="zh-CN" sz="1300"/>
          </a:p>
        </p:txBody>
      </p:sp>
      <p:sp>
        <p:nvSpPr>
          <p:cNvPr id="8" name="文本框 7"/>
          <p:cNvSpPr txBox="1"/>
          <p:nvPr/>
        </p:nvSpPr>
        <p:spPr>
          <a:xfrm>
            <a:off x="238817" y="9333919"/>
            <a:ext cx="3396568" cy="2914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300"/>
              <a:t>b. </a:t>
            </a:r>
            <a:r>
              <a:rPr lang="en-US" altLang="zh-CN" sz="1300">
                <a:sym typeface="+mn-ea"/>
              </a:rPr>
              <a:t>Meta-analysis of marital duration</a:t>
            </a:r>
            <a:r>
              <a:rPr lang="en-US" altLang="zh-CN" sz="1300"/>
              <a:t> </a:t>
            </a:r>
            <a:endParaRPr lang="en-US" altLang="zh-CN" sz="130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" name="文本框 9"/>
          <p:cNvSpPr txBox="1"/>
          <p:nvPr/>
        </p:nvSpPr>
        <p:spPr>
          <a:xfrm>
            <a:off x="123838" y="296488"/>
            <a:ext cx="8164487" cy="3155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60"/>
              <a:t>Fig. S4. Meta-analysis of educational attainment and fertility.</a:t>
            </a:r>
            <a:endParaRPr lang="en-US" altLang="zh-CN" sz="1460"/>
          </a:p>
        </p:txBody>
      </p:sp>
      <p:pic>
        <p:nvPicPr>
          <p:cNvPr id="11" name="图片 10" descr="education"/>
          <p:cNvPicPr>
            <a:picLocks noChangeAspect="1"/>
          </p:cNvPicPr>
          <p:nvPr/>
        </p:nvPicPr>
        <p:blipFill>
          <a:blip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123778" y="930923"/>
            <a:ext cx="6482172" cy="3571926"/>
          </a:xfrm>
          <a:prstGeom prst="rect">
            <a:avLst/>
          </a:prstGeom>
        </p:spPr>
      </p:pic>
      <p:pic>
        <p:nvPicPr>
          <p:cNvPr id="12" name="图片 11" descr="Fertility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58704" y="5166433"/>
            <a:ext cx="6447246" cy="3847519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158774" y="4673666"/>
            <a:ext cx="2352073" cy="37084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5"/>
              <a:t>a. </a:t>
            </a:r>
            <a:r>
              <a:rPr lang="en-US" altLang="zh-CN" sz="905">
                <a:sym typeface="+mn-ea"/>
              </a:rPr>
              <a:t>Meta-analysis of educational attainment</a:t>
            </a:r>
            <a:r>
              <a:rPr lang="en-US" altLang="zh-CN" sz="905"/>
              <a:t> </a:t>
            </a:r>
            <a:endParaRPr lang="en-US" altLang="zh-CN" sz="905"/>
          </a:p>
        </p:txBody>
      </p:sp>
      <p:sp>
        <p:nvSpPr>
          <p:cNvPr id="14" name="文本框 13"/>
          <p:cNvSpPr txBox="1"/>
          <p:nvPr/>
        </p:nvSpPr>
        <p:spPr>
          <a:xfrm>
            <a:off x="158774" y="9277481"/>
            <a:ext cx="1542415" cy="23114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905">
                <a:sym typeface="+mn-ea"/>
              </a:rPr>
              <a:t>b. Meta-analysis of fertility</a:t>
            </a:r>
            <a:endParaRPr lang="zh-CN" altLang="en-US" sz="905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1</Words>
  <Application>WPS 文字</Application>
  <PresentationFormat>宽屏</PresentationFormat>
  <Paragraphs>16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6" baseType="lpstr">
      <vt:lpstr>Arial</vt:lpstr>
      <vt:lpstr>方正书宋_GBK</vt:lpstr>
      <vt:lpstr>Wingdings</vt:lpstr>
      <vt:lpstr>Calibri Light</vt:lpstr>
      <vt:lpstr>Helvetica Neue</vt:lpstr>
      <vt:lpstr>宋体</vt:lpstr>
      <vt:lpstr>汉仪书宋二KW</vt:lpstr>
      <vt:lpstr>Calibri</vt:lpstr>
      <vt:lpstr>微软雅黑</vt:lpstr>
      <vt:lpstr>汉仪旗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angxinys</dc:creator>
  <cp:lastModifiedBy>liangxinys</cp:lastModifiedBy>
  <cp:revision>16</cp:revision>
  <dcterms:created xsi:type="dcterms:W3CDTF">2022-03-14T15:06:47Z</dcterms:created>
  <dcterms:modified xsi:type="dcterms:W3CDTF">2022-03-14T15:0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3.9.3.6359</vt:lpwstr>
  </property>
</Properties>
</file>